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17C03-92EC-4C9F-BD2C-DB868FBDC8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AA3F4-33E2-4AAE-A290-4EB2934714E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DD3E9-460D-4F6F-99FC-4158C973EF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B3283-24E3-4354-A865-20BF5FEF3A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6D3961-C1C0-469E-811D-CE1FD6A716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B61A82-F21B-4A5F-9758-C1FFFA8324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1D4C51-E3AA-48BB-8ED5-4208A05165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394CC6-2D4F-40E3-A459-0F757C4216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21A065-3822-4D3D-97AB-E3FCC1385A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261A6-1ADC-4BA4-ABDA-D8AE985CF4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E81D0-B5B7-4F93-ADEC-17D2DEF2AA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5E308-A803-4DDB-9AB5-92529C86CF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9F8C10-4ECE-4357-8FD7-39CF435A8C2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henotypic characterization of phylogenetically diverse intestinal spore-forming bacteri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3147840" y="1181160"/>
            <a:ext cx="2848320" cy="45259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 P Brown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–4 (2016) doi:10.1038/nature1764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29T09:21:38Z</dcterms:created>
  <dc:creator>ravikumar.n</dc:creator>
  <dc:description/>
  <dc:language>en-US</dc:language>
  <cp:lastModifiedBy>R.Vijitha</cp:lastModifiedBy>
  <dcterms:modified xsi:type="dcterms:W3CDTF">2016-04-29T09:24:28Z</dcterms:modified>
  <cp:revision>2</cp:revision>
  <dc:subject/>
  <dc:title>Phenotypic characterization of phylogenetically diverse intestinal spore-forming bacteria</dc:title>
</cp:coreProperties>
</file>